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405"/>
  </p:normalViewPr>
  <p:slideViewPr>
    <p:cSldViewPr snapToGrid="0" snapToObjects="1" showGuides="1">
      <p:cViewPr varScale="1">
        <p:scale>
          <a:sx n="117" d="100"/>
          <a:sy n="117" d="100"/>
        </p:scale>
        <p:origin x="318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E53E36-ABDE-2B43-B581-77EA42B2C8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AD01379-B369-6945-8E21-F1D8633211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2A1041-EA00-CE46-8F46-2AEE7342B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99DAF8-2BD2-9948-866D-F14408884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1863A7-6AED-A54D-BC38-49740855B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075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9AB050-4AAC-CD4A-B8D0-FB58C2C15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C636681-51FB-DE43-B74D-B01EB46331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6A8A2A-D945-9240-BBC7-B5F46628C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BC77D0-70F3-A246-8F4F-DB08C464E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5BFD50-1E62-E64F-8F9F-03F1D0330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665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2F8652A-0D35-C14E-8747-DC1B479047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1C8F909-0456-F845-9AEF-9289AB0EAD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4EB268-6D5B-024B-A2FE-A11A3368E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004B44-C24D-0741-AF71-D02C193A9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32A3D6-FC10-7C46-B6AB-1D693C34C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6284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57052C-78F1-A647-93FB-A31E8791D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D79C34F-5207-2C4A-9147-3B60B6FEBB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A108E4-9CAB-8549-B4D3-E9CC83F04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F357B1-FB24-8847-976D-D36682E7D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7F119A-025B-1440-B22B-973494A50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549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40D663-C755-4C4A-BF6F-C5FFD7CD5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E44DF8-0046-8D42-835F-91702D1FDF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96531A-694A-3D42-8DBD-206DA5E46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55395C-B599-1947-B110-F5F94E0DC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E584C1-D3F8-6A45-A0CB-FA5D587F4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84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6E0CBF-CED3-6547-BA0E-58D1A47703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BBBBCDF-81F6-914A-BCD0-71D913C3D3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5705045-2C9B-854F-AD63-6B470497E6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ECAEC7-B371-3446-99A1-30E761890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23D662-25F8-D543-80E8-5BEFF6D9C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0B74C9-8978-044C-A094-DAC3A3C6F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498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421822-949A-744B-A078-B00FFE18F8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BE54B49-73C3-F349-AF70-54B6E72D05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9BACEA-70AF-5F47-84C2-8DE968034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54B8579-21AE-AD49-A920-A72E492976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FF72712-C274-D043-B9AD-1DC11CCABB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91441EB-027B-784B-9F75-2DED786AA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BBBFD7E-ED84-844B-A454-A438CBE9A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D6415E6-9EEA-704E-A0CC-47CBA95FA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2320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249303-AE52-A54A-947B-BCAFF53CC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88BDFCF-345A-A048-875B-8AB05EFA3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5A918FE-8CD8-1E42-B816-9D8514013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CA03A30-E97E-1E49-8E99-36515A4CF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730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75ECECA-01C1-4547-81A3-C1F494DEB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E8D5ADF-17E3-3848-9726-521CB93FB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A0D8089-7297-7846-A7AC-89B512B01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456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F9194D-DBF6-CA4B-B58F-6E73ED47DC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A61230-116D-1942-B6B5-F285889544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42F9F3A-657F-2F45-8A30-76F12223CB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8DB9E5E-7350-B84F-899F-98AF46D49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D30C86-01CC-F946-BF65-6C75C6981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8FB97DB-C103-8C4C-BF8E-0BBDC748E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436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0CB8CE-B175-3045-8CE5-EACE3ED42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4FA6C9-6ECE-5143-A26F-C9E9663997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160F78B-C227-3644-9CD8-F810E387B4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588C25F-93C8-294F-A382-2AE0969B7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6DEA9F-7859-A44A-877A-3F47F2F47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6B6EED9-2FFD-4446-98C9-AD1C5A89E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3101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DD93AF1-0353-DB47-8B53-E21CCF034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B151BE-B1C2-A047-8D52-7B240AA5A3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B52003-B0B8-7C43-BAA9-87ED94E63C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6A0D4-6D22-2E48-9069-8E6902380A59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507878-857E-B144-AD79-50F87AEB2F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F31C78-B374-7146-A7AF-70171D67C3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CB1F9-5115-454C-A7ED-2E044FD68C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94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>
            <a:extLst>
              <a:ext uri="{FF2B5EF4-FFF2-40B4-BE49-F238E27FC236}">
                <a16:creationId xmlns:a16="http://schemas.microsoft.com/office/drawing/2014/main" id="{5D575945-911C-5BE6-0E91-69227FA556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509" t="9362" r="3496" b="24989"/>
          <a:stretch/>
        </p:blipFill>
        <p:spPr>
          <a:xfrm>
            <a:off x="926070" y="217397"/>
            <a:ext cx="6943040" cy="5559042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978DBA7-08A4-9247-9CC1-285F3DF2793E}"/>
              </a:ext>
            </a:extLst>
          </p:cNvPr>
          <p:cNvSpPr/>
          <p:nvPr/>
        </p:nvSpPr>
        <p:spPr>
          <a:xfrm>
            <a:off x="5604456" y="757805"/>
            <a:ext cx="300553" cy="982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2660">
            <a:extLst>
              <a:ext uri="{FF2B5EF4-FFF2-40B4-BE49-F238E27FC236}">
                <a16:creationId xmlns:a16="http://schemas.microsoft.com/office/drawing/2014/main" id="{0B12E391-00B6-6747-9507-05239663781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621447" y="2759020"/>
            <a:ext cx="214161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Overall survival (%)</a:t>
            </a:r>
            <a:endParaRPr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C5833B7-575B-4941-BBFB-BCAFE0921A9E}"/>
              </a:ext>
            </a:extLst>
          </p:cNvPr>
          <p:cNvSpPr txBox="1"/>
          <p:nvPr/>
        </p:nvSpPr>
        <p:spPr>
          <a:xfrm>
            <a:off x="549042" y="1349547"/>
            <a:ext cx="44114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D754862-0E53-D04C-B6B4-69632CAE6ACD}"/>
              </a:ext>
            </a:extLst>
          </p:cNvPr>
          <p:cNvSpPr txBox="1"/>
          <p:nvPr/>
        </p:nvSpPr>
        <p:spPr>
          <a:xfrm>
            <a:off x="7250413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A482A4C-9A99-4F42-81FD-4CB0F1312DD6}"/>
              </a:ext>
            </a:extLst>
          </p:cNvPr>
          <p:cNvSpPr txBox="1"/>
          <p:nvPr/>
        </p:nvSpPr>
        <p:spPr>
          <a:xfrm>
            <a:off x="6043240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32A852E-80D8-094F-B2B6-988F557A8783}"/>
              </a:ext>
            </a:extLst>
          </p:cNvPr>
          <p:cNvSpPr txBox="1"/>
          <p:nvPr/>
        </p:nvSpPr>
        <p:spPr>
          <a:xfrm>
            <a:off x="4849321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FFE6855-A9BE-6E4B-8DF0-278D9F59AF57}"/>
              </a:ext>
            </a:extLst>
          </p:cNvPr>
          <p:cNvSpPr txBox="1"/>
          <p:nvPr/>
        </p:nvSpPr>
        <p:spPr>
          <a:xfrm>
            <a:off x="2447658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03A4BB2-274D-BE48-8995-090A33EF6315}"/>
              </a:ext>
            </a:extLst>
          </p:cNvPr>
          <p:cNvSpPr txBox="1"/>
          <p:nvPr/>
        </p:nvSpPr>
        <p:spPr>
          <a:xfrm>
            <a:off x="1231512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67947EE-3F9C-C347-BF9A-DD8AF0B73C64}"/>
              </a:ext>
            </a:extLst>
          </p:cNvPr>
          <p:cNvSpPr txBox="1"/>
          <p:nvPr/>
        </p:nvSpPr>
        <p:spPr>
          <a:xfrm>
            <a:off x="613163" y="5183433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C3927E1-EA35-774B-B067-9BA4E44CF66A}"/>
              </a:ext>
            </a:extLst>
          </p:cNvPr>
          <p:cNvSpPr txBox="1"/>
          <p:nvPr/>
        </p:nvSpPr>
        <p:spPr>
          <a:xfrm>
            <a:off x="549042" y="4212235"/>
            <a:ext cx="44114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ECDC817-6694-9E46-B5B8-175A2513139C}"/>
              </a:ext>
            </a:extLst>
          </p:cNvPr>
          <p:cNvSpPr txBox="1"/>
          <p:nvPr/>
        </p:nvSpPr>
        <p:spPr>
          <a:xfrm>
            <a:off x="549042" y="3254023"/>
            <a:ext cx="44114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51A92E1-79D0-B444-B01E-77A2BCD359FF}"/>
              </a:ext>
            </a:extLst>
          </p:cNvPr>
          <p:cNvSpPr txBox="1"/>
          <p:nvPr/>
        </p:nvSpPr>
        <p:spPr>
          <a:xfrm>
            <a:off x="549042" y="2315276"/>
            <a:ext cx="44114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7D14C31-EFF9-924C-BC16-DE84014E3802}"/>
              </a:ext>
            </a:extLst>
          </p:cNvPr>
          <p:cNvSpPr txBox="1"/>
          <p:nvPr/>
        </p:nvSpPr>
        <p:spPr>
          <a:xfrm>
            <a:off x="484921" y="412725"/>
            <a:ext cx="56938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578">
            <a:extLst>
              <a:ext uri="{FF2B5EF4-FFF2-40B4-BE49-F238E27FC236}">
                <a16:creationId xmlns:a16="http://schemas.microsoft.com/office/drawing/2014/main" id="{B821BD7D-4310-454C-B72E-0730BA05EE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3582" y="1287265"/>
            <a:ext cx="519802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rge prognostic difference in obese patients</a:t>
            </a:r>
          </a:p>
        </p:txBody>
      </p:sp>
      <p:sp>
        <p:nvSpPr>
          <p:cNvPr id="18" name="Line 4">
            <a:extLst>
              <a:ext uri="{FF2B5EF4-FFF2-40B4-BE49-F238E27FC236}">
                <a16:creationId xmlns:a16="http://schemas.microsoft.com/office/drawing/2014/main" id="{DAC7F07B-09FF-FD43-844F-5222C14F7833}"/>
              </a:ext>
            </a:extLst>
          </p:cNvPr>
          <p:cNvSpPr>
            <a:spLocks noChangeShapeType="1"/>
          </p:cNvSpPr>
          <p:nvPr/>
        </p:nvSpPr>
        <p:spPr bwMode="auto">
          <a:xfrm>
            <a:off x="10516144" y="2025575"/>
            <a:ext cx="0" cy="1198414"/>
          </a:xfrm>
          <a:prstGeom prst="line">
            <a:avLst/>
          </a:prstGeom>
          <a:noFill/>
          <a:ln w="57150">
            <a:solidFill>
              <a:srgbClr val="FF0000"/>
            </a:solidFill>
            <a:round/>
            <a:headEnd type="arrow" w="med" len="med"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EFBD2B0-6D3C-A84A-B80D-DEE2F113828D}"/>
              </a:ext>
            </a:extLst>
          </p:cNvPr>
          <p:cNvSpPr txBox="1"/>
          <p:nvPr/>
        </p:nvSpPr>
        <p:spPr>
          <a:xfrm>
            <a:off x="3629285" y="5727450"/>
            <a:ext cx="3129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A8BFE901-6841-1A43-B289-E56016A663CA}"/>
              </a:ext>
            </a:extLst>
          </p:cNvPr>
          <p:cNvCxnSpPr>
            <a:cxnSpLocks/>
          </p:cNvCxnSpPr>
          <p:nvPr/>
        </p:nvCxnSpPr>
        <p:spPr>
          <a:xfrm>
            <a:off x="7466783" y="3287306"/>
            <a:ext cx="3043704" cy="0"/>
          </a:xfrm>
          <a:prstGeom prst="line">
            <a:avLst/>
          </a:prstGeom>
          <a:ln w="28575">
            <a:solidFill>
              <a:schemeClr val="accent5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BFD641C8-D639-B44E-BD01-6135D3A80E16}"/>
              </a:ext>
            </a:extLst>
          </p:cNvPr>
          <p:cNvCxnSpPr>
            <a:cxnSpLocks/>
          </p:cNvCxnSpPr>
          <p:nvPr/>
        </p:nvCxnSpPr>
        <p:spPr>
          <a:xfrm>
            <a:off x="7466783" y="2050288"/>
            <a:ext cx="3043704" cy="0"/>
          </a:xfrm>
          <a:prstGeom prst="line">
            <a:avLst/>
          </a:prstGeom>
          <a:ln w="28575">
            <a:solidFill>
              <a:srgbClr val="92D050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DF763830-B061-4A4D-BA85-628E30F76433}"/>
              </a:ext>
            </a:extLst>
          </p:cNvPr>
          <p:cNvCxnSpPr>
            <a:cxnSpLocks/>
          </p:cNvCxnSpPr>
          <p:nvPr/>
        </p:nvCxnSpPr>
        <p:spPr>
          <a:xfrm>
            <a:off x="7422792" y="2986372"/>
            <a:ext cx="339915" cy="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D0FBC330-8576-704A-8EE0-B159D1AA7E4C}"/>
              </a:ext>
            </a:extLst>
          </p:cNvPr>
          <p:cNvCxnSpPr>
            <a:cxnSpLocks/>
          </p:cNvCxnSpPr>
          <p:nvPr/>
        </p:nvCxnSpPr>
        <p:spPr>
          <a:xfrm>
            <a:off x="7418755" y="2583385"/>
            <a:ext cx="339915" cy="0"/>
          </a:xfrm>
          <a:prstGeom prst="line">
            <a:avLst/>
          </a:prstGeom>
          <a:ln w="63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Line 6">
            <a:extLst>
              <a:ext uri="{FF2B5EF4-FFF2-40B4-BE49-F238E27FC236}">
                <a16:creationId xmlns:a16="http://schemas.microsoft.com/office/drawing/2014/main" id="{35759ADA-FB60-F24C-8336-7C274362C1F2}"/>
              </a:ext>
            </a:extLst>
          </p:cNvPr>
          <p:cNvSpPr>
            <a:spLocks noChangeShapeType="1"/>
          </p:cNvSpPr>
          <p:nvPr/>
        </p:nvSpPr>
        <p:spPr bwMode="auto">
          <a:xfrm>
            <a:off x="7734159" y="2599902"/>
            <a:ext cx="0" cy="344804"/>
          </a:xfrm>
          <a:prstGeom prst="line">
            <a:avLst/>
          </a:prstGeom>
          <a:noFill/>
          <a:ln w="12700">
            <a:solidFill>
              <a:srgbClr val="0432FF"/>
            </a:solidFill>
            <a:round/>
            <a:headEnd type="arrow" w="med" len="med"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b="1">
              <a:solidFill>
                <a:srgbClr val="043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1580">
            <a:extLst>
              <a:ext uri="{FF2B5EF4-FFF2-40B4-BE49-F238E27FC236}">
                <a16:creationId xmlns:a16="http://schemas.microsoft.com/office/drawing/2014/main" id="{AFB05EDD-4642-C346-AA93-D61E85CF1B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1010" y="3390210"/>
            <a:ext cx="759289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prognostic difference in non-obese patients</a:t>
            </a:r>
          </a:p>
        </p:txBody>
      </p:sp>
      <p:sp>
        <p:nvSpPr>
          <p:cNvPr id="27" name="Rectangle 1568">
            <a:extLst>
              <a:ext uri="{FF2B5EF4-FFF2-40B4-BE49-F238E27FC236}">
                <a16:creationId xmlns:a16="http://schemas.microsoft.com/office/drawing/2014/main" id="{CC8868F3-1829-D147-BA36-D7A99E7C6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60603" y="1688000"/>
            <a:ext cx="82926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AIC (-)</a:t>
            </a:r>
            <a:endParaRPr lang="en-US" altLang="ja-JP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1571">
            <a:extLst>
              <a:ext uri="{FF2B5EF4-FFF2-40B4-BE49-F238E27FC236}">
                <a16:creationId xmlns:a16="http://schemas.microsoft.com/office/drawing/2014/main" id="{EA5BE018-F828-0C4D-9C68-57961E78EB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37565" y="2236731"/>
            <a:ext cx="982725" cy="335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C (-) </a:t>
            </a:r>
            <a:endParaRPr lang="en-US" altLang="ja-JP" b="1" dirty="0">
              <a:solidFill>
                <a:srgbClr val="0432FF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9" name="Rectangle 1574">
            <a:extLst>
              <a:ext uri="{FF2B5EF4-FFF2-40B4-BE49-F238E27FC236}">
                <a16:creationId xmlns:a16="http://schemas.microsoft.com/office/drawing/2014/main" id="{E89B6427-CFAF-FA43-9625-5C5A2A270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60603" y="3342386"/>
            <a:ext cx="8869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C (+)</a:t>
            </a:r>
            <a:endParaRPr lang="en-US" altLang="ja-JP" b="1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0" name="Rectangle 1577">
            <a:extLst>
              <a:ext uri="{FF2B5EF4-FFF2-40B4-BE49-F238E27FC236}">
                <a16:creationId xmlns:a16="http://schemas.microsoft.com/office/drawing/2014/main" id="{D4E69D22-253A-EA4D-B34A-27399CA0B3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37565" y="2902441"/>
            <a:ext cx="1822057" cy="335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altLang="ja-JP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C (+)</a:t>
            </a:r>
            <a:r>
              <a:rPr lang="en-US" altLang="ja-JP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endParaRPr lang="en-US" altLang="ja-JP" b="1" dirty="0">
              <a:solidFill>
                <a:srgbClr val="0432FF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DCBC3B0-FC34-504D-B13C-F50B1D4DF613}"/>
              </a:ext>
            </a:extLst>
          </p:cNvPr>
          <p:cNvSpPr txBox="1"/>
          <p:nvPr/>
        </p:nvSpPr>
        <p:spPr>
          <a:xfrm>
            <a:off x="3343167" y="6006682"/>
            <a:ext cx="2275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Years after surgery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09446DE1-17BF-85A7-4731-C6C80EEA296B}"/>
              </a:ext>
            </a:extLst>
          </p:cNvPr>
          <p:cNvGrpSpPr/>
          <p:nvPr/>
        </p:nvGrpSpPr>
        <p:grpSpPr>
          <a:xfrm>
            <a:off x="1552172" y="3947770"/>
            <a:ext cx="4133613" cy="1486339"/>
            <a:chOff x="7294517" y="80390"/>
            <a:chExt cx="4133613" cy="1486339"/>
          </a:xfrm>
        </p:grpSpPr>
        <p:grpSp>
          <p:nvGrpSpPr>
            <p:cNvPr id="38" name="Group 1581">
              <a:extLst>
                <a:ext uri="{FF2B5EF4-FFF2-40B4-BE49-F238E27FC236}">
                  <a16:creationId xmlns:a16="http://schemas.microsoft.com/office/drawing/2014/main" id="{5A8782D9-3E54-6B4C-864D-2DC76F1AB4F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697503" y="167835"/>
              <a:ext cx="3730627" cy="1398894"/>
              <a:chOff x="3056" y="1288"/>
              <a:chExt cx="2350" cy="606"/>
            </a:xfrm>
          </p:grpSpPr>
          <p:sp>
            <p:nvSpPr>
              <p:cNvPr id="39" name="Line 1566">
                <a:extLst>
                  <a:ext uri="{FF2B5EF4-FFF2-40B4-BE49-F238E27FC236}">
                    <a16:creationId xmlns:a16="http://schemas.microsoft.com/office/drawing/2014/main" id="{1E5FC20E-520F-164B-9353-4342033667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6" y="1374"/>
                <a:ext cx="133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Oval 1567">
                <a:extLst>
                  <a:ext uri="{FF2B5EF4-FFF2-40B4-BE49-F238E27FC236}">
                    <a16:creationId xmlns:a16="http://schemas.microsoft.com/office/drawing/2014/main" id="{BC6BB979-6DA7-C54D-8892-4EA9D7F7DD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" y="1355"/>
                <a:ext cx="37" cy="37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1568">
                <a:extLst>
                  <a:ext uri="{FF2B5EF4-FFF2-40B4-BE49-F238E27FC236}">
                    <a16:creationId xmlns:a16="http://schemas.microsoft.com/office/drawing/2014/main" id="{05A56981-E271-A74B-A455-46D346134E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1" y="1288"/>
                <a:ext cx="2154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PAIC (-)  and BMI &lt; 25      n = 75</a:t>
                </a:r>
                <a:endParaRPr lang="en-US" altLang="ja-JP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1569">
                <a:extLst>
                  <a:ext uri="{FF2B5EF4-FFF2-40B4-BE49-F238E27FC236}">
                    <a16:creationId xmlns:a16="http://schemas.microsoft.com/office/drawing/2014/main" id="{2F412983-8DB8-814A-AD79-F76B47E1DB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6" y="1512"/>
                <a:ext cx="133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1570">
                <a:extLst>
                  <a:ext uri="{FF2B5EF4-FFF2-40B4-BE49-F238E27FC236}">
                    <a16:creationId xmlns:a16="http://schemas.microsoft.com/office/drawing/2014/main" id="{C1A61BD7-252B-1943-AC6D-F1C6A26B56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" y="1493"/>
                <a:ext cx="37" cy="37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1571">
                <a:extLst>
                  <a:ext uri="{FF2B5EF4-FFF2-40B4-BE49-F238E27FC236}">
                    <a16:creationId xmlns:a16="http://schemas.microsoft.com/office/drawing/2014/main" id="{B1A871D2-958C-7F48-A3D9-D1F5108D55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1" y="1426"/>
                <a:ext cx="215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IC (+) and BMI &lt; 25      </a:t>
                </a:r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n = 15</a:t>
                </a:r>
              </a:p>
            </p:txBody>
          </p:sp>
          <p:sp>
            <p:nvSpPr>
              <p:cNvPr id="45" name="Line 1572">
                <a:extLst>
                  <a:ext uri="{FF2B5EF4-FFF2-40B4-BE49-F238E27FC236}">
                    <a16:creationId xmlns:a16="http://schemas.microsoft.com/office/drawing/2014/main" id="{48FB772B-3470-EE4A-ACEA-4126587D9C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4" y="1801"/>
                <a:ext cx="133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Oval 1573">
                <a:extLst>
                  <a:ext uri="{FF2B5EF4-FFF2-40B4-BE49-F238E27FC236}">
                    <a16:creationId xmlns:a16="http://schemas.microsoft.com/office/drawing/2014/main" id="{F0F04334-29C8-F348-934E-7046C14A50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1" y="1782"/>
                <a:ext cx="37" cy="37"/>
              </a:xfrm>
              <a:prstGeom prst="ellipse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1574">
                <a:extLst>
                  <a:ext uri="{FF2B5EF4-FFF2-40B4-BE49-F238E27FC236}">
                    <a16:creationId xmlns:a16="http://schemas.microsoft.com/office/drawing/2014/main" id="{C2DCB2B6-2112-4A45-8E3A-D205E5B18E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9" y="1720"/>
                <a:ext cx="215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IC (+) and BMI 25 </a:t>
                </a:r>
                <a:r>
                  <a:rPr lang="en-US" altLang="ja-JP" b="1" u="sng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&lt;</a:t>
                </a:r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n = 16</a:t>
                </a:r>
              </a:p>
            </p:txBody>
          </p:sp>
          <p:sp>
            <p:nvSpPr>
              <p:cNvPr id="48" name="Line 1575">
                <a:extLst>
                  <a:ext uri="{FF2B5EF4-FFF2-40B4-BE49-F238E27FC236}">
                    <a16:creationId xmlns:a16="http://schemas.microsoft.com/office/drawing/2014/main" id="{FD12C64B-A708-804E-A854-BB5F4843A6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6" y="1662"/>
                <a:ext cx="13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1576">
                <a:extLst>
                  <a:ext uri="{FF2B5EF4-FFF2-40B4-BE49-F238E27FC236}">
                    <a16:creationId xmlns:a16="http://schemas.microsoft.com/office/drawing/2014/main" id="{ABCDDCB3-0A67-B144-B5B5-2647E9DD2D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" y="1643"/>
                <a:ext cx="37" cy="37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1577">
                <a:extLst>
                  <a:ext uri="{FF2B5EF4-FFF2-40B4-BE49-F238E27FC236}">
                    <a16:creationId xmlns:a16="http://schemas.microsoft.com/office/drawing/2014/main" id="{820ECC32-8DBC-EF4C-807E-E55DECC3FA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11" y="1570"/>
                <a:ext cx="2195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IC (-) and  BMI 25</a:t>
                </a:r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&lt;</a:t>
                </a:r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altLang="ja-JP" b="1" dirty="0">
                    <a:solidFill>
                      <a:srgbClr val="000000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n = 74</a:t>
                </a:r>
              </a:p>
            </p:txBody>
          </p:sp>
        </p:grpSp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334C859D-C9FA-1944-8983-7A65A5C410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294517" y="80390"/>
              <a:ext cx="658612" cy="1371183"/>
            </a:xfrm>
            <a:prstGeom prst="rect">
              <a:avLst/>
            </a:prstGeom>
          </p:spPr>
        </p:pic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FBB3EA4-0ACD-43BF-16E3-5121BDD3F07E}"/>
              </a:ext>
            </a:extLst>
          </p:cNvPr>
          <p:cNvSpPr txBox="1"/>
          <p:nvPr/>
        </p:nvSpPr>
        <p:spPr>
          <a:xfrm>
            <a:off x="181466" y="6317254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760EE05-55AC-3E5E-BE59-49189E5CD811}"/>
              </a:ext>
            </a:extLst>
          </p:cNvPr>
          <p:cNvSpPr txBox="1"/>
          <p:nvPr/>
        </p:nvSpPr>
        <p:spPr>
          <a:xfrm>
            <a:off x="10774049" y="2503892"/>
            <a:ext cx="1169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&lt;</a:t>
            </a:r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.001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F53EDB0-56D1-5757-8194-AF1392FA010F}"/>
              </a:ext>
            </a:extLst>
          </p:cNvPr>
          <p:cNvSpPr txBox="1"/>
          <p:nvPr/>
        </p:nvSpPr>
        <p:spPr>
          <a:xfrm>
            <a:off x="8528355" y="2527498"/>
            <a:ext cx="1169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b="1" i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0.350</a:t>
            </a:r>
          </a:p>
        </p:txBody>
      </p:sp>
    </p:spTree>
    <p:extLst>
      <p:ext uri="{BB962C8B-B14F-4D97-AF65-F5344CB8AC3E}">
        <p14:creationId xmlns:p14="http://schemas.microsoft.com/office/powerpoint/2010/main" val="1623883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FA621D-6EF8-1335-7A21-4406F9B9E4B0}"/>
              </a:ext>
            </a:extLst>
          </p:cNvPr>
          <p:cNvSpPr txBox="1"/>
          <p:nvPr/>
        </p:nvSpPr>
        <p:spPr>
          <a:xfrm>
            <a:off x="758757" y="64202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7DFB889-416D-4B8B-31BC-68BEB71E6C2D}"/>
              </a:ext>
            </a:extLst>
          </p:cNvPr>
          <p:cNvSpPr txBox="1"/>
          <p:nvPr/>
        </p:nvSpPr>
        <p:spPr>
          <a:xfrm>
            <a:off x="298911" y="458995"/>
            <a:ext cx="10539135" cy="2546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pplemental figure 2.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Overall survival curves according to the combination of PAIC and obesity status. In 180 consecutive patients with 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Stage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II–III GC after propensity score matching, there was a large and significant prognostic difference between non-PAIC and PAIC obese patients (</a:t>
            </a:r>
            <a:r>
              <a:rPr lang="en-GB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&lt; 0.001; 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5-year overall survival: 69.7% vs. 43.8%). In contrast, there was a small prognostic difference between non-PAIC and PAIC non-obese patients (</a:t>
            </a:r>
            <a:r>
              <a:rPr lang="en-GB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= 0.350; 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5-year overall survival: 58.6% vs. 50.0%)</a:t>
            </a:r>
            <a:r>
              <a:rPr lang="en-GB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.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>
              <a:lnSpc>
                <a:spcPct val="150000"/>
              </a:lnSpc>
            </a:pP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941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175</Words>
  <Application>Microsoft Office PowerPoint</Application>
  <PresentationFormat>ワイド画面</PresentationFormat>
  <Paragraphs>2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神谷 肇</dc:creator>
  <cp:lastModifiedBy>Shuhei Komatsu</cp:lastModifiedBy>
  <cp:revision>26</cp:revision>
  <dcterms:created xsi:type="dcterms:W3CDTF">2021-12-01T04:47:02Z</dcterms:created>
  <dcterms:modified xsi:type="dcterms:W3CDTF">2023-06-05T09:08:59Z</dcterms:modified>
</cp:coreProperties>
</file>